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3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91B6E-DD85-76F5-572D-5B283F611A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F97B54-B01C-F307-92B0-45FE54A302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0C5D81-BE07-67FC-2412-361DF9F95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616F01-3548-29AB-F0F8-9A1FDDCF7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6AA3C-E054-AC18-C6A8-97E162B4A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650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470E5-35EB-A23A-2079-BB9871CDA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362F4-D07B-1E1F-0961-5B36A78C19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1DB674-5B17-DD21-E71E-1E23E6FCC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775AD-5139-1CC2-AEEE-C7274F615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FB8E08-27DA-4AF6-1F0A-387854ACB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852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CE7323-38EA-D133-4522-CAB0A60EF4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B51A9B-4906-BAC8-5169-9C71FC2EB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CF110F-2C3C-8FC7-F4F8-A43226068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BA0F0-1AAC-1D6D-E001-A5A21194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8FF68D-5A61-9352-0335-87C1A6761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32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4FF59-D2FC-1A00-53D8-76A301DF1E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05ED88-C146-71E4-D52B-8A82D42D17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300F5-F703-297B-FF23-5DC3EE62A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C5522F-2E8A-C27A-513D-EF13B12F3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3E46C-71B7-3B86-1E1F-BF18FC584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417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7590A-469A-54E1-15FE-C4DB0324F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44BB84-F999-7B0C-2227-43FAD38FF3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FFED6-3544-5224-8696-91BA07BBB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1C4F66-8158-9CBB-61FA-EB7B13DC4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998BF8-2F7C-E9EE-6DF9-2EF54F1E9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012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A97D0-45D6-CD76-511D-A234E84807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BC010-D56B-1D68-89FA-062F874BA8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27F600-0533-19EE-47B9-C4BA6369C7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2539F1-605E-EE35-73DD-09D18ED8A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119D70-99CF-51DB-CE9D-9C8C7E564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DA7AC8-40BF-3057-C590-18BE2C412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087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13718-4BA8-D322-FF13-98AA9A9E5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535FE9-5C4B-17D7-BB59-A961C5EE7F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6250D9-6D6A-E6E5-471C-8002643EC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43EF32-884B-EF2E-0979-42C0118DCE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354C19-30FA-41EB-3C5C-6E4EED4854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429C22-7D79-733B-9F9F-4EFE47ABF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61135C-861B-AED4-E692-8020D4785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FCED44-FC99-C913-0FA5-85F87B8B5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770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654DB-71D3-C547-4BA8-E0F93B3AE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DD4700-575A-9FB4-51DF-AFADC4602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4AFD67-5E06-90F9-5329-47574129B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BEF4F3-6800-CE73-182B-2858396C3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43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581F51-4A85-AF76-7BC1-DE09A2DB2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EE7159-7E52-C584-D711-53A768BDD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CD1CC9-67EB-96A5-E90C-762130DFE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007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D631AF-32FB-F978-CD96-50E0B0E041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B1ED3B-01F5-CC44-95B6-1A15E1BC4C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5EE9F9-6317-FC5F-538C-3ADF09AA73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8B52E2-379D-08BB-4BD0-66F920E03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4F40B-2543-765E-DC0B-F82B19D46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22EB29-FC5F-C9FD-F09E-97A2D04FD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168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74128-E041-D9EA-D695-63D135E57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FCE3E4-9E9A-02F4-7967-ACFB507F9E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2CA2C-E588-0949-E3D4-B06EC90D33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FB69B-B3DA-0F22-B4F0-0976230EC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BE11B9-7675-7A9A-A892-97CA47F4E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ADA8A-C690-6BC5-238F-81BF6D77D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872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288017-75BD-C380-5C1F-6C0260E0A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44FACF-2A33-D139-4804-40BB926BD7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5004FB-6988-09C4-218D-923AC21E2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BBA40-421C-259A-884B-22367F06A1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740E4E-11A4-F140-7277-1E982CA26F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364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>
            <a:extLst>
              <a:ext uri="{FF2B5EF4-FFF2-40B4-BE49-F238E27FC236}">
                <a16:creationId xmlns:a16="http://schemas.microsoft.com/office/drawing/2014/main" id="{AC8C2681-13C6-1EFA-5B28-605768459A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09800" y="131450"/>
            <a:ext cx="7886700" cy="681353"/>
          </a:xfrm>
        </p:spPr>
        <p:txBody>
          <a:bodyPr>
            <a:normAutofit fontScale="90000"/>
          </a:bodyPr>
          <a:lstStyle/>
          <a:p>
            <a:pPr algn="ctr"/>
            <a:r>
              <a:rPr lang="en-US" b="1" dirty="0">
                <a:latin typeface="Garamond" panose="02020404030301010803" pitchFamily="18" charset="0"/>
              </a:rPr>
              <a:t>GAN CRISPR Clones</a:t>
            </a:r>
          </a:p>
        </p:txBody>
      </p:sp>
      <p:sp>
        <p:nvSpPr>
          <p:cNvPr id="25" name="Text Placeholder 2">
            <a:extLst>
              <a:ext uri="{FF2B5EF4-FFF2-40B4-BE49-F238E27FC236}">
                <a16:creationId xmlns:a16="http://schemas.microsoft.com/office/drawing/2014/main" id="{B7E13F80-AB95-842C-F897-8F43A0DE3B5C}"/>
              </a:ext>
            </a:extLst>
          </p:cNvPr>
          <p:cNvSpPr txBox="1">
            <a:spLocks/>
          </p:cNvSpPr>
          <p:nvPr/>
        </p:nvSpPr>
        <p:spPr>
          <a:xfrm>
            <a:off x="3041235" y="680090"/>
            <a:ext cx="2357040" cy="458786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>
                <a:latin typeface="Garamond" panose="02020404030301010803" pitchFamily="18" charset="0"/>
              </a:rPr>
              <a:t>Clone 1C1.1</a:t>
            </a:r>
            <a:endParaRPr lang="en-US" dirty="0">
              <a:latin typeface="Garamond" panose="02020404030301010803" pitchFamily="18" charset="0"/>
            </a:endParaRPr>
          </a:p>
        </p:txBody>
      </p:sp>
      <p:pic>
        <p:nvPicPr>
          <p:cNvPr id="26" name="Content Placeholder 9">
            <a:extLst>
              <a:ext uri="{FF2B5EF4-FFF2-40B4-BE49-F238E27FC236}">
                <a16:creationId xmlns:a16="http://schemas.microsoft.com/office/drawing/2014/main" id="{D55894F6-EE3D-3418-384C-EBD40E21132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5387" y="1148234"/>
            <a:ext cx="3228736" cy="3228736"/>
          </a:xfrm>
          <a:prstGeom prst="rect">
            <a:avLst/>
          </a:prstGeom>
        </p:spPr>
      </p:pic>
      <p:sp>
        <p:nvSpPr>
          <p:cNvPr id="27" name="Text Placeholder 4">
            <a:extLst>
              <a:ext uri="{FF2B5EF4-FFF2-40B4-BE49-F238E27FC236}">
                <a16:creationId xmlns:a16="http://schemas.microsoft.com/office/drawing/2014/main" id="{087BDD7C-E573-D704-053C-0B08F22B9E9D}"/>
              </a:ext>
            </a:extLst>
          </p:cNvPr>
          <p:cNvSpPr txBox="1">
            <a:spLocks/>
          </p:cNvSpPr>
          <p:nvPr/>
        </p:nvSpPr>
        <p:spPr>
          <a:xfrm>
            <a:off x="6800341" y="644530"/>
            <a:ext cx="2467531" cy="529906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>
                <a:latin typeface="Garamond" panose="02020404030301010803" pitchFamily="18" charset="0"/>
              </a:rPr>
              <a:t>Clone 1C1.2</a:t>
            </a:r>
            <a:endParaRPr lang="en-US" dirty="0">
              <a:latin typeface="Garamond" panose="02020404030301010803" pitchFamily="18" charset="0"/>
            </a:endParaRPr>
          </a:p>
        </p:txBody>
      </p:sp>
      <p:pic>
        <p:nvPicPr>
          <p:cNvPr id="28" name="Content Placeholder 13" descr="A picture containing text&#10;&#10;Description automatically generated">
            <a:extLst>
              <a:ext uri="{FF2B5EF4-FFF2-40B4-BE49-F238E27FC236}">
                <a16:creationId xmlns:a16="http://schemas.microsoft.com/office/drawing/2014/main" id="{86300975-960F-AFD3-31B9-1782D0A7480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6711" y="1144402"/>
            <a:ext cx="3232568" cy="3232568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B1017F31-9902-911D-D530-120A2A4B3D9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5692" y="4747967"/>
            <a:ext cx="3082043" cy="2054695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64C6A705-06E9-4D6C-ECCC-E113EB2F675A}"/>
              </a:ext>
            </a:extLst>
          </p:cNvPr>
          <p:cNvSpPr txBox="1"/>
          <p:nvPr/>
        </p:nvSpPr>
        <p:spPr>
          <a:xfrm>
            <a:off x="5138554" y="4386331"/>
            <a:ext cx="28491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Garamond" panose="02020404030301010803" pitchFamily="18" charset="0"/>
              </a:rPr>
              <a:t>Parental ME 180 cell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FD3208E-C7D4-6F87-7F50-0356E68F74FC}"/>
              </a:ext>
            </a:extLst>
          </p:cNvPr>
          <p:cNvSpPr txBox="1"/>
          <p:nvPr/>
        </p:nvSpPr>
        <p:spPr>
          <a:xfrm>
            <a:off x="798348" y="5063435"/>
            <a:ext cx="332129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7. Parental </a:t>
            </a:r>
          </a:p>
          <a:p>
            <a:r>
              <a:rPr lang="en-US" dirty="0"/>
              <a:t>ME180 and CRISPR-Cas9 clones</a:t>
            </a:r>
          </a:p>
        </p:txBody>
      </p:sp>
    </p:spTree>
    <p:extLst>
      <p:ext uri="{BB962C8B-B14F-4D97-AF65-F5344CB8AC3E}">
        <p14:creationId xmlns:p14="http://schemas.microsoft.com/office/powerpoint/2010/main" val="1865506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20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Garamond</vt:lpstr>
      <vt:lpstr>Office Theme</vt:lpstr>
      <vt:lpstr>GAN CRISPR Clon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vatsan, Eri S. (he/him/his)</dc:creator>
  <cp:lastModifiedBy>Srivatsan, Eri S. (he/him/his)</cp:lastModifiedBy>
  <cp:revision>6</cp:revision>
  <dcterms:created xsi:type="dcterms:W3CDTF">2024-02-09T21:19:49Z</dcterms:created>
  <dcterms:modified xsi:type="dcterms:W3CDTF">2024-02-09T21:47:08Z</dcterms:modified>
</cp:coreProperties>
</file>